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67" r:id="rId3"/>
    <p:sldId id="26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D4F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063"/>
    <p:restoredTop sz="82782"/>
  </p:normalViewPr>
  <p:slideViewPr>
    <p:cSldViewPr snapToGrid="0" snapToObjects="1">
      <p:cViewPr varScale="1">
        <p:scale>
          <a:sx n="103" d="100"/>
          <a:sy n="103" d="100"/>
        </p:scale>
        <p:origin x="872" y="184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6CA501-39AB-A74E-9492-05C82B2D8A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47CC862-140F-E941-9473-44E14CB408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79C4E2-9D4B-6C41-8F33-3D4727D6E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8BD1D4-7884-6946-8BD6-2C051C2BB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7D78C7C-DFDB-AE4B-BE10-4502B6FD9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228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07C5F05-9FD0-084F-95A7-F11F1CF903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B6CFBD1-DD84-9A46-A63D-C5EA476BEB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6A2B6C6-C047-384E-95A7-E711FEAB9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06C8530-2F52-E34E-9F26-4F84FC88F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0A2E6C-8FED-D84B-937A-1497950BB5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232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3D81987-7046-4643-8C87-EC3C1A61DA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1769720-C31F-DB44-9D60-DDA44D4A15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BFC39E-E128-9A43-9135-A804CC244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721C61-B133-D74E-8C1E-EEC8089830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B71B654-84C8-AC49-8D26-AB385925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838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3AB355-1DA8-3D4B-9264-C9A8B0D8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5144485-F467-5343-8653-12DE968761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469618-C8E7-8F49-AD61-923C4B20E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7E3CD3-9C37-1A47-970C-78E30EBD7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D55D17-E560-284E-9742-53C294BBB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840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C57264-4DFB-AF47-91C8-03F88B4C6E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4C04339-56BB-B944-9938-39E53B528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E64009-6B88-E049-A346-962E538C4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6FA827-F763-7A4E-AD95-93DD4C529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F7ADC6-4D33-D349-8636-EC300C735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17489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5A2F6F-FEFF-F740-A1F1-7592BF0C3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921EB98-0E4B-274A-872A-6E05509BA3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AF82A20-F479-BB47-8ECE-1FF1DF8494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C26EAD7-F8D9-0641-9069-0E3F4BDA5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597892-C909-9744-A7E2-15F6096F6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5C6E093-A928-8541-BD39-CFB5CC7CD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409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D4568B-D785-2347-BB13-A718200DD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4A6BDE2-EBEC-7742-BE3B-290B03C91C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0CC0576-588C-C247-9AD0-8B2D61AFBA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B99EE1E-1B87-C846-AB75-F5389FA51F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26F0F29-F7C7-5747-BB7D-7B1D1C6A86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CD3AD72-176F-F642-8111-CE7DFEDAA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6CE5A79-4F65-5C42-B00B-11BDDBD15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014B3F5-C5AB-2246-B863-A4EE3F19A2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272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FB845D-6978-D045-9448-352C1EB01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56E7835-1EDA-CE44-B5FE-20CDFA95C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947AB12-ABDA-5944-B06E-77724E97F8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0B4BD79-CE1B-8940-8BB5-F49345B03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6623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1C26AE4-6CF2-534B-B693-37012DD0D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30C9681-4E07-2E43-99B8-1C4B83742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9DEE692-74A6-6545-822D-4C7CD67E7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81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1D130E5-568D-B24D-8C88-A2A4199F8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6818AE3-51C8-8E47-A817-2F3076F487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0BD8640-7055-D143-BCEB-CDC0FCC068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7792E64-48F7-9942-BBF4-E003F2B30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63C487-703F-DB48-B6F7-24E9F3588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4D0191-86FB-5843-A18B-B26A4FF40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024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8BC985-74EE-F74F-8938-78668F742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6107837-C5DF-D246-8AD0-B2719C15C6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0289B44-C238-744E-9515-5223B95944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FE4AC76-8453-F648-BE00-3CD1705AA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B1047DB-9FC8-8C4A-8E19-AEB80D51C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8FCD2E-D378-6145-BF19-3D00C0C35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450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5A87237-2B0B-A541-BDFC-BEC00FD1A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3BBA26-0095-5341-98CA-7D11937564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16874B-B1EA-1440-A98F-85D70C9BC3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08418-8B2D-0244-BC33-C6F92E2A717C}" type="datetimeFigureOut">
              <a:rPr kumimoji="1" lang="ja-JP" altLang="en-US" smtClean="0"/>
              <a:t>2023/8/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1F68E0-006D-0E41-96CC-22060F7A8D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19F7C8-F03C-8D49-BB55-D8F9CBC7A3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B6BB5-DE93-DD4C-A105-94EF9A3FACE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1147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220011-C32F-FE09-E41D-48EC20CC7F68}"/>
              </a:ext>
            </a:extLst>
          </p:cNvPr>
          <p:cNvSpPr txBox="1"/>
          <p:nvPr/>
        </p:nvSpPr>
        <p:spPr>
          <a:xfrm>
            <a:off x="0" y="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F5256D93-4A8F-2718-5F93-44CC68BEB81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2103" r="44726"/>
          <a:stretch/>
        </p:blipFill>
        <p:spPr>
          <a:xfrm>
            <a:off x="1799897" y="1200345"/>
            <a:ext cx="4296103" cy="29999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1F47A3-39CB-7AEF-0913-605C3A647DF3}"/>
              </a:ext>
            </a:extLst>
          </p:cNvPr>
          <p:cNvSpPr txBox="1"/>
          <p:nvPr/>
        </p:nvSpPr>
        <p:spPr>
          <a:xfrm>
            <a:off x="5377534" y="3830990"/>
            <a:ext cx="718466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89BE4483-A4C1-E4B5-8073-8E46955D805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" t="41940" r="44726" b="1"/>
          <a:stretch/>
        </p:blipFill>
        <p:spPr>
          <a:xfrm>
            <a:off x="6096000" y="1200345"/>
            <a:ext cx="4296103" cy="29999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C61394-E5AE-62C2-B8DF-5241DB0C6CB7}"/>
              </a:ext>
            </a:extLst>
          </p:cNvPr>
          <p:cNvSpPr txBox="1"/>
          <p:nvPr/>
        </p:nvSpPr>
        <p:spPr>
          <a:xfrm>
            <a:off x="9673637" y="3830990"/>
            <a:ext cx="718466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F4F88C-B0EE-58F1-6609-901383B1449B}"/>
              </a:ext>
            </a:extLst>
          </p:cNvPr>
          <p:cNvSpPr txBox="1"/>
          <p:nvPr/>
        </p:nvSpPr>
        <p:spPr>
          <a:xfrm>
            <a:off x="2445143" y="4641992"/>
            <a:ext cx="7301713" cy="14202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 1: Representative features of </a:t>
            </a:r>
            <a:r>
              <a:rPr lang="el-GR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β-</a:t>
            </a: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catenin</a:t>
            </a:r>
          </a:p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left: </a:t>
            </a:r>
            <a:r>
              <a:rPr lang="el-GR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β-</a:t>
            </a: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catenin expression in nucleus </a:t>
            </a:r>
          </a:p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right:  </a:t>
            </a:r>
            <a:r>
              <a:rPr lang="el-GR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β-</a:t>
            </a: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catenin expression in cell membrane</a:t>
            </a:r>
          </a:p>
        </p:txBody>
      </p:sp>
    </p:spTree>
    <p:extLst>
      <p:ext uri="{BB962C8B-B14F-4D97-AF65-F5344CB8AC3E}">
        <p14:creationId xmlns:p14="http://schemas.microsoft.com/office/powerpoint/2010/main" val="3073006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4470624D-D9FA-DC65-DABD-CFE166A410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1941" r="44726"/>
          <a:stretch/>
        </p:blipFill>
        <p:spPr>
          <a:xfrm>
            <a:off x="1799897" y="1200345"/>
            <a:ext cx="4296103" cy="299997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D0D2ACAC-E6EC-50B0-480F-3CBD499EBB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1941" r="44726"/>
          <a:stretch/>
        </p:blipFill>
        <p:spPr>
          <a:xfrm>
            <a:off x="6096000" y="1200345"/>
            <a:ext cx="4296103" cy="299997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220011-C32F-FE09-E41D-48EC20CC7F68}"/>
              </a:ext>
            </a:extLst>
          </p:cNvPr>
          <p:cNvSpPr txBox="1"/>
          <p:nvPr/>
        </p:nvSpPr>
        <p:spPr>
          <a:xfrm>
            <a:off x="0" y="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 2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1F47A3-39CB-7AEF-0913-605C3A647DF3}"/>
              </a:ext>
            </a:extLst>
          </p:cNvPr>
          <p:cNvSpPr txBox="1"/>
          <p:nvPr/>
        </p:nvSpPr>
        <p:spPr>
          <a:xfrm>
            <a:off x="5377534" y="3830990"/>
            <a:ext cx="718466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C61394-E5AE-62C2-B8DF-5241DB0C6CB7}"/>
              </a:ext>
            </a:extLst>
          </p:cNvPr>
          <p:cNvSpPr txBox="1"/>
          <p:nvPr/>
        </p:nvSpPr>
        <p:spPr>
          <a:xfrm>
            <a:off x="9673637" y="3830990"/>
            <a:ext cx="718466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F4F88C-B0EE-58F1-6609-901383B1449B}"/>
              </a:ext>
            </a:extLst>
          </p:cNvPr>
          <p:cNvSpPr txBox="1"/>
          <p:nvPr/>
        </p:nvSpPr>
        <p:spPr>
          <a:xfrm>
            <a:off x="1842517" y="4641992"/>
            <a:ext cx="8506965" cy="14202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 2: Representative features of </a:t>
            </a:r>
            <a:r>
              <a:rPr lang="en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glutamine synthetase</a:t>
            </a:r>
            <a:endParaRPr lang="en-US" altLang="ja-JP" sz="2000" dirty="0"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left: No expression of </a:t>
            </a:r>
            <a:r>
              <a:rPr lang="en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glutamine synthetase</a:t>
            </a:r>
          </a:p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right:  Expression of </a:t>
            </a:r>
            <a:r>
              <a:rPr lang="en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glutamine synthetase</a:t>
            </a: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 in cytoplasm</a:t>
            </a:r>
          </a:p>
        </p:txBody>
      </p:sp>
    </p:spTree>
    <p:extLst>
      <p:ext uri="{BB962C8B-B14F-4D97-AF65-F5344CB8AC3E}">
        <p14:creationId xmlns:p14="http://schemas.microsoft.com/office/powerpoint/2010/main" val="21304937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8F8ECB86-A4E7-4EEB-D9C8-D3B2E09369E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t="45273" r="47898"/>
          <a:stretch/>
        </p:blipFill>
        <p:spPr>
          <a:xfrm>
            <a:off x="6096000" y="1200344"/>
            <a:ext cx="4296104" cy="29999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6E78DC3-7654-BDB4-4AA6-D0C7F109B9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1941" r="44726"/>
          <a:stretch/>
        </p:blipFill>
        <p:spPr>
          <a:xfrm>
            <a:off x="1799896" y="1200345"/>
            <a:ext cx="4296103" cy="29999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5220011-C32F-FE09-E41D-48EC20CC7F68}"/>
              </a:ext>
            </a:extLst>
          </p:cNvPr>
          <p:cNvSpPr txBox="1"/>
          <p:nvPr/>
        </p:nvSpPr>
        <p:spPr>
          <a:xfrm>
            <a:off x="0" y="0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 3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81F47A3-39CB-7AEF-0913-605C3A647DF3}"/>
              </a:ext>
            </a:extLst>
          </p:cNvPr>
          <p:cNvSpPr txBox="1"/>
          <p:nvPr/>
        </p:nvSpPr>
        <p:spPr>
          <a:xfrm>
            <a:off x="5377534" y="3830990"/>
            <a:ext cx="718466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C61394-E5AE-62C2-B8DF-5241DB0C6CB7}"/>
              </a:ext>
            </a:extLst>
          </p:cNvPr>
          <p:cNvSpPr txBox="1"/>
          <p:nvPr/>
        </p:nvSpPr>
        <p:spPr>
          <a:xfrm>
            <a:off x="9673637" y="3830990"/>
            <a:ext cx="718466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X100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F4F88C-B0EE-58F1-6609-901383B1449B}"/>
              </a:ext>
            </a:extLst>
          </p:cNvPr>
          <p:cNvSpPr txBox="1"/>
          <p:nvPr/>
        </p:nvSpPr>
        <p:spPr>
          <a:xfrm>
            <a:off x="2138619" y="4654366"/>
            <a:ext cx="8253484" cy="14202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Supplemental Figure 3: Representative features of OATP1B3</a:t>
            </a:r>
          </a:p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left: No expression of </a:t>
            </a:r>
            <a:r>
              <a:rPr lang="en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glutamine synthetase</a:t>
            </a:r>
          </a:p>
          <a:p>
            <a:pPr>
              <a:lnSpc>
                <a:spcPct val="150000"/>
              </a:lnSpc>
            </a:pPr>
            <a:r>
              <a:rPr lang="en-US" altLang="ja-JP" sz="2000" dirty="0"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right: Expression of OATP1B3 in cell membrane of normal liver</a:t>
            </a:r>
          </a:p>
        </p:txBody>
      </p:sp>
    </p:spTree>
    <p:extLst>
      <p:ext uri="{BB962C8B-B14F-4D97-AF65-F5344CB8AC3E}">
        <p14:creationId xmlns:p14="http://schemas.microsoft.com/office/powerpoint/2010/main" val="596161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9</TotalTime>
  <Words>89</Words>
  <Application>Microsoft Macintosh PowerPoint</Application>
  <PresentationFormat>ワイド画面</PresentationFormat>
  <Paragraphs>18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7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利田 賢哉</dc:creator>
  <cp:lastModifiedBy>Microsoft Office User</cp:lastModifiedBy>
  <cp:revision>53</cp:revision>
  <dcterms:created xsi:type="dcterms:W3CDTF">2022-02-15T10:00:43Z</dcterms:created>
  <dcterms:modified xsi:type="dcterms:W3CDTF">2023-08-06T04:03:42Z</dcterms:modified>
</cp:coreProperties>
</file>